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033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9" autoAdjust="0"/>
    <p:restoredTop sz="94660"/>
  </p:normalViewPr>
  <p:slideViewPr>
    <p:cSldViewPr snapToGrid="0">
      <p:cViewPr varScale="1">
        <p:scale>
          <a:sx n="88" d="100"/>
          <a:sy n="88" d="100"/>
        </p:scale>
        <p:origin x="60" y="11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32A087-610C-4A2D-BFEA-E6066072FA9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6A305-A877-46CB-B3A9-E825BD77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749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93D687-7917-AF96-2083-BE5DD69C6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AF580E-271C-8573-A3AA-4322C5765A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7BC2A9-1C8D-DDB1-AB7F-E52517630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4D75D6-E805-9CF8-A5F1-0DDD97D7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49A2D-2565-4DA1-E34A-3AC918FB2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63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4FA41-7EFE-6CAE-D360-A80A551A5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3220CC2-E885-8272-61F0-F9F1F656D7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B22F4-F981-E8C9-4BA6-3AEECA3AA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780BB2-32C1-5B04-739B-D23591A7F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A7D371-A86D-4C9F-D31D-B2F1559E4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74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A7970E-AA44-1220-F769-6638911B88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8A34B9-CA3F-55BD-41AF-2C33927B0D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CFFA9D-EA35-12BA-6663-ACB7CBF7A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5CE27D-48F2-926E-8040-12A43D0D5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E07559-6E9F-25A2-A47A-DABDAB16A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136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A45D0-D37A-BB53-3B0C-AF4E38B3D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9B368A-2498-49E1-645B-C20F1B319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D663C3-9C20-BE3B-25A6-E162F19CE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58F056-DA08-3D99-648D-4EDA929DE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ACA2E3-97EE-016D-743E-E81B67BFA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473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3181D5-C4A7-38C5-319E-1E572617E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9D4C25-2B17-4F77-84EA-A20A157E0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FEB64D-19F5-08BE-EAEF-87DF709C1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07549D-ABA3-EB08-8290-44E3B04E8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BED87E-53CF-DEF2-DCD3-80E2DE3CF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93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9E8176-966B-00DC-47EF-80D1A9F53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F2C4EF-7CF5-65C5-ECA5-79D17119B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CC36BA-FB16-683C-862E-29F5F70829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3D69E1-81B7-BDFA-471C-A237BE47D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72E425-3DF6-E4E1-CF4F-01D76A2AA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490298-196B-F248-42A0-31A06A7C9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95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5912B-9EB8-A6D9-430A-074890A91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7711D1-44E9-ACD2-996B-FEAACEDB2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574325-69CA-AC0A-B752-311A35A39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B8EB0C-0AEE-1577-72A6-FD080455F1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231AAA8-FD7D-BCDD-16B4-24F9F37929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1E3ABF-20BD-CD53-ED40-F4E92255C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F2AC9D-B694-C637-4096-383B889E3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287BCBB-6053-DAF6-2F9C-133E49C16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098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E92910-1DEB-DF57-99D2-269E69BDB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C3186B7-007E-5664-5002-BA742C6A3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1975313-6A14-36F6-2637-CAEE52EAB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795A2A-0464-7A95-F016-018C8C07F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19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31F1F0-3983-57BD-2019-A9FA64A9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CA3F45-BFDC-C997-7C5F-096D07C4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7D842F-D802-6E74-102E-932E2489F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944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A8639-4CCA-D974-9CD5-B707C245A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14FE5A-DEAD-053C-5C0D-D5AD817772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7B511F-8209-5F5B-BE99-5C037D5F4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3B58B4-4BCC-BE4B-BAF5-28152A33A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C01102-C8F0-117D-8D40-A7D3AFBC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DED17E-2CD0-AE71-99A0-C44091AC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8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34AEB-83A9-33DF-0078-3ADFF9CE3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20EE52E-E90B-561A-0BD6-932FBEF63F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1153CF-B0F9-6EDE-3D79-D827745D7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D5CB949-6EB0-0C73-598D-0BF1D14B6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106B57-279C-DC9B-138A-79C275570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11062D-AC7B-41E2-BA17-62C67C80C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025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3EF9513-5A52-1EE3-9387-48A0DBF1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F3A20-4EBC-4306-0981-7A43D4C29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C7209-ACFD-1433-A499-8D0198D20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89A36-B8B9-4551-861A-5DD988DED30A}" type="datetimeFigureOut">
              <a:rPr kumimoji="1" lang="ja-JP" altLang="en-US" smtClean="0"/>
              <a:t>2025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22CF8-3547-B503-50A9-AF94430923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EBC64B-F869-48AF-3263-860E06C47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89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4F692DE-243D-7402-79CE-7A422F1F15FA}"/>
              </a:ext>
            </a:extLst>
          </p:cNvPr>
          <p:cNvSpPr txBox="1"/>
          <p:nvPr/>
        </p:nvSpPr>
        <p:spPr>
          <a:xfrm>
            <a:off x="20697" y="5187379"/>
            <a:ext cx="1215060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  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onships betwee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let-to-lymphocyte ratio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t 2 weeks after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urvalumab plus </a:t>
            </a:r>
            <a:r>
              <a:rPr lang="en-US" altLang="ja-JP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melimumab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roduction 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change of the amount of lymphocyte count between at baseline and at 2 weeks after 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urvalumab plus </a:t>
            </a:r>
            <a:r>
              <a:rPr lang="en-US" altLang="ja-JP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melimumab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roduction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breviations: PLR2w,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let-to-lymphocyte ratio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t 2 weeks after </a:t>
            </a:r>
            <a:r>
              <a:rPr lang="en-US" altLang="ja-JP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urvalumab plus </a:t>
            </a:r>
            <a:r>
              <a:rPr lang="en-US" altLang="ja-JP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melimumab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roduction; </a:t>
            </a:r>
            <a:r>
              <a:rPr lang="en-US" altLang="ja-JP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Δlymphocyte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calculated as the change of the amount of lymphocyte count between at baseline and at 2 weeks after 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urvalumab plus </a:t>
            </a:r>
            <a:r>
              <a:rPr lang="en-US" altLang="ja-JP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emelimumab</a:t>
            </a:r>
            <a:r>
              <a:rPr lang="en-US" altLang="ja-JP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roduction.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9" name="グループ化 128"/>
          <p:cNvGrpSpPr/>
          <p:nvPr/>
        </p:nvGrpSpPr>
        <p:grpSpPr>
          <a:xfrm>
            <a:off x="997273" y="360789"/>
            <a:ext cx="6526346" cy="4577677"/>
            <a:chOff x="1789518" y="1221045"/>
            <a:chExt cx="6526346" cy="4577677"/>
          </a:xfrm>
        </p:grpSpPr>
        <p:sp>
          <p:nvSpPr>
            <p:cNvPr id="11" name="Line 8"/>
            <p:cNvSpPr>
              <a:spLocks noChangeShapeType="1"/>
            </p:cNvSpPr>
            <p:nvPr/>
          </p:nvSpPr>
          <p:spPr bwMode="auto">
            <a:xfrm flipV="1">
              <a:off x="2850104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9"/>
            <p:cNvSpPr>
              <a:spLocks noChangeShapeType="1"/>
            </p:cNvSpPr>
            <p:nvPr/>
          </p:nvSpPr>
          <p:spPr bwMode="auto">
            <a:xfrm flipV="1">
              <a:off x="3713475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10"/>
            <p:cNvSpPr>
              <a:spLocks noChangeShapeType="1"/>
            </p:cNvSpPr>
            <p:nvPr/>
          </p:nvSpPr>
          <p:spPr bwMode="auto">
            <a:xfrm flipV="1">
              <a:off x="4576846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1"/>
            <p:cNvSpPr>
              <a:spLocks noChangeShapeType="1"/>
            </p:cNvSpPr>
            <p:nvPr/>
          </p:nvSpPr>
          <p:spPr bwMode="auto">
            <a:xfrm flipV="1">
              <a:off x="5438864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2"/>
            <p:cNvSpPr>
              <a:spLocks noChangeShapeType="1"/>
            </p:cNvSpPr>
            <p:nvPr/>
          </p:nvSpPr>
          <p:spPr bwMode="auto">
            <a:xfrm flipV="1">
              <a:off x="6302234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13"/>
            <p:cNvSpPr>
              <a:spLocks noChangeShapeType="1"/>
            </p:cNvSpPr>
            <p:nvPr/>
          </p:nvSpPr>
          <p:spPr bwMode="auto">
            <a:xfrm flipV="1">
              <a:off x="7165605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14"/>
            <p:cNvSpPr>
              <a:spLocks noChangeShapeType="1"/>
            </p:cNvSpPr>
            <p:nvPr/>
          </p:nvSpPr>
          <p:spPr bwMode="auto">
            <a:xfrm flipV="1">
              <a:off x="8027622" y="5224247"/>
              <a:ext cx="0" cy="102911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Line 15"/>
            <p:cNvSpPr>
              <a:spLocks noChangeShapeType="1"/>
            </p:cNvSpPr>
            <p:nvPr/>
          </p:nvSpPr>
          <p:spPr bwMode="auto">
            <a:xfrm>
              <a:off x="2563216" y="5121431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Line 16"/>
            <p:cNvSpPr>
              <a:spLocks noChangeShapeType="1"/>
            </p:cNvSpPr>
            <p:nvPr/>
          </p:nvSpPr>
          <p:spPr bwMode="auto">
            <a:xfrm>
              <a:off x="2563216" y="4505764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Line 17"/>
            <p:cNvSpPr>
              <a:spLocks noChangeShapeType="1"/>
            </p:cNvSpPr>
            <p:nvPr/>
          </p:nvSpPr>
          <p:spPr bwMode="auto">
            <a:xfrm>
              <a:off x="2563216" y="3888585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Line 18"/>
            <p:cNvSpPr>
              <a:spLocks noChangeShapeType="1"/>
            </p:cNvSpPr>
            <p:nvPr/>
          </p:nvSpPr>
          <p:spPr bwMode="auto">
            <a:xfrm>
              <a:off x="2563216" y="3269894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Line 19"/>
            <p:cNvSpPr>
              <a:spLocks noChangeShapeType="1"/>
            </p:cNvSpPr>
            <p:nvPr/>
          </p:nvSpPr>
          <p:spPr bwMode="auto">
            <a:xfrm>
              <a:off x="2563216" y="2654227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Line 20"/>
            <p:cNvSpPr>
              <a:spLocks noChangeShapeType="1"/>
            </p:cNvSpPr>
            <p:nvPr/>
          </p:nvSpPr>
          <p:spPr bwMode="auto">
            <a:xfrm>
              <a:off x="2563216" y="2037048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21"/>
            <p:cNvSpPr>
              <a:spLocks noChangeShapeType="1"/>
            </p:cNvSpPr>
            <p:nvPr/>
          </p:nvSpPr>
          <p:spPr bwMode="auto">
            <a:xfrm>
              <a:off x="2563216" y="1419869"/>
              <a:ext cx="920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22"/>
            <p:cNvSpPr>
              <a:spLocks noChangeShapeType="1"/>
            </p:cNvSpPr>
            <p:nvPr/>
          </p:nvSpPr>
          <p:spPr bwMode="auto">
            <a:xfrm>
              <a:off x="2563216" y="5327158"/>
              <a:ext cx="575264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Rectangle 24"/>
            <p:cNvSpPr>
              <a:spLocks noChangeArrowheads="1"/>
            </p:cNvSpPr>
            <p:nvPr/>
          </p:nvSpPr>
          <p:spPr bwMode="auto">
            <a:xfrm>
              <a:off x="7936889" y="5374051"/>
              <a:ext cx="19677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5"/>
            <p:cNvSpPr>
              <a:spLocks noChangeArrowheads="1"/>
            </p:cNvSpPr>
            <p:nvPr/>
          </p:nvSpPr>
          <p:spPr bwMode="auto">
            <a:xfrm>
              <a:off x="7071588" y="5374051"/>
              <a:ext cx="19677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6"/>
            <p:cNvSpPr>
              <a:spLocks noChangeArrowheads="1"/>
            </p:cNvSpPr>
            <p:nvPr/>
          </p:nvSpPr>
          <p:spPr bwMode="auto">
            <a:xfrm>
              <a:off x="6207829" y="5374051"/>
              <a:ext cx="19677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7"/>
            <p:cNvSpPr>
              <a:spLocks noChangeArrowheads="1"/>
            </p:cNvSpPr>
            <p:nvPr/>
          </p:nvSpPr>
          <p:spPr bwMode="auto">
            <a:xfrm>
              <a:off x="5341751" y="5374051"/>
              <a:ext cx="19677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8"/>
            <p:cNvSpPr>
              <a:spLocks noChangeArrowheads="1"/>
            </p:cNvSpPr>
            <p:nvPr/>
          </p:nvSpPr>
          <p:spPr bwMode="auto">
            <a:xfrm>
              <a:off x="4480122" y="5374051"/>
              <a:ext cx="19677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9"/>
            <p:cNvSpPr>
              <a:spLocks noChangeArrowheads="1"/>
            </p:cNvSpPr>
            <p:nvPr/>
          </p:nvSpPr>
          <p:spPr bwMode="auto">
            <a:xfrm>
              <a:off x="3649419" y="5374051"/>
              <a:ext cx="13118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0"/>
            <p:cNvSpPr>
              <a:spLocks noChangeArrowheads="1"/>
            </p:cNvSpPr>
            <p:nvPr/>
          </p:nvSpPr>
          <p:spPr bwMode="auto">
            <a:xfrm>
              <a:off x="2814783" y="5374051"/>
              <a:ext cx="65590" cy="175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31"/>
            <p:cNvSpPr>
              <a:spLocks noChangeShapeType="1"/>
            </p:cNvSpPr>
            <p:nvPr/>
          </p:nvSpPr>
          <p:spPr bwMode="auto">
            <a:xfrm>
              <a:off x="2563216" y="1221045"/>
              <a:ext cx="0" cy="411452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Rectangle 41"/>
            <p:cNvSpPr>
              <a:spLocks noChangeArrowheads="1"/>
            </p:cNvSpPr>
            <p:nvPr/>
          </p:nvSpPr>
          <p:spPr bwMode="auto">
            <a:xfrm>
              <a:off x="2184317" y="1323501"/>
              <a:ext cx="3077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2"/>
            <p:cNvSpPr>
              <a:spLocks noChangeArrowheads="1"/>
            </p:cNvSpPr>
            <p:nvPr/>
          </p:nvSpPr>
          <p:spPr bwMode="auto">
            <a:xfrm>
              <a:off x="2184317" y="1947803"/>
              <a:ext cx="3077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/>
            <p:cNvSpPr>
              <a:spLocks noChangeArrowheads="1"/>
            </p:cNvSpPr>
            <p:nvPr/>
          </p:nvSpPr>
          <p:spPr bwMode="auto">
            <a:xfrm>
              <a:off x="2261262" y="2563690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4"/>
            <p:cNvSpPr>
              <a:spLocks noChangeArrowheads="1"/>
            </p:cNvSpPr>
            <p:nvPr/>
          </p:nvSpPr>
          <p:spPr bwMode="auto">
            <a:xfrm>
              <a:off x="2415150" y="3179577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5"/>
            <p:cNvSpPr>
              <a:spLocks noChangeArrowheads="1"/>
            </p:cNvSpPr>
            <p:nvPr/>
          </p:nvSpPr>
          <p:spPr bwMode="auto">
            <a:xfrm>
              <a:off x="2173096" y="3798269"/>
              <a:ext cx="318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/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6"/>
            <p:cNvSpPr>
              <a:spLocks noChangeArrowheads="1"/>
            </p:cNvSpPr>
            <p:nvPr/>
          </p:nvSpPr>
          <p:spPr bwMode="auto">
            <a:xfrm>
              <a:off x="2096152" y="4410690"/>
              <a:ext cx="3959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/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7"/>
            <p:cNvSpPr>
              <a:spLocks noChangeArrowheads="1"/>
            </p:cNvSpPr>
            <p:nvPr/>
          </p:nvSpPr>
          <p:spPr bwMode="auto">
            <a:xfrm>
              <a:off x="2096152" y="5029381"/>
              <a:ext cx="3959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/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Oval 48"/>
            <p:cNvSpPr>
              <a:spLocks noChangeAspect="1" noChangeArrowheads="1"/>
            </p:cNvSpPr>
            <p:nvPr/>
          </p:nvSpPr>
          <p:spPr bwMode="auto">
            <a:xfrm>
              <a:off x="6162843" y="3312242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Oval 49"/>
            <p:cNvSpPr>
              <a:spLocks noChangeAspect="1" noChangeArrowheads="1"/>
            </p:cNvSpPr>
            <p:nvPr/>
          </p:nvSpPr>
          <p:spPr bwMode="auto">
            <a:xfrm>
              <a:off x="6162843" y="3312242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Oval 50"/>
            <p:cNvSpPr>
              <a:spLocks noChangeAspect="1" noChangeArrowheads="1"/>
            </p:cNvSpPr>
            <p:nvPr/>
          </p:nvSpPr>
          <p:spPr bwMode="auto">
            <a:xfrm>
              <a:off x="5008525" y="3395439"/>
              <a:ext cx="68204" cy="74424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Oval 51"/>
            <p:cNvSpPr>
              <a:spLocks noChangeAspect="1" noChangeArrowheads="1"/>
            </p:cNvSpPr>
            <p:nvPr/>
          </p:nvSpPr>
          <p:spPr bwMode="auto">
            <a:xfrm>
              <a:off x="5008525" y="3395439"/>
              <a:ext cx="68204" cy="74424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Oval 52"/>
            <p:cNvSpPr>
              <a:spLocks noChangeAspect="1" noChangeArrowheads="1"/>
            </p:cNvSpPr>
            <p:nvPr/>
          </p:nvSpPr>
          <p:spPr bwMode="auto">
            <a:xfrm>
              <a:off x="4154626" y="1900898"/>
              <a:ext cx="68204" cy="74424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Oval 53"/>
            <p:cNvSpPr>
              <a:spLocks noChangeAspect="1" noChangeArrowheads="1"/>
            </p:cNvSpPr>
            <p:nvPr/>
          </p:nvSpPr>
          <p:spPr bwMode="auto">
            <a:xfrm>
              <a:off x="4154626" y="1900898"/>
              <a:ext cx="68204" cy="74424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Oval 54"/>
            <p:cNvSpPr>
              <a:spLocks noChangeAspect="1" noChangeArrowheads="1"/>
            </p:cNvSpPr>
            <p:nvPr/>
          </p:nvSpPr>
          <p:spPr bwMode="auto">
            <a:xfrm>
              <a:off x="5820472" y="3269886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Oval 55"/>
            <p:cNvSpPr>
              <a:spLocks noChangeAspect="1" noChangeArrowheads="1"/>
            </p:cNvSpPr>
            <p:nvPr/>
          </p:nvSpPr>
          <p:spPr bwMode="auto">
            <a:xfrm>
              <a:off x="5820472" y="3269886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Oval 56"/>
            <p:cNvSpPr>
              <a:spLocks noChangeAspect="1" noChangeArrowheads="1"/>
            </p:cNvSpPr>
            <p:nvPr/>
          </p:nvSpPr>
          <p:spPr bwMode="auto">
            <a:xfrm>
              <a:off x="4874553" y="3111053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Oval 57"/>
            <p:cNvSpPr>
              <a:spLocks noChangeAspect="1" noChangeArrowheads="1"/>
            </p:cNvSpPr>
            <p:nvPr/>
          </p:nvSpPr>
          <p:spPr bwMode="auto">
            <a:xfrm>
              <a:off x="4874553" y="3111053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Oval 58"/>
            <p:cNvSpPr>
              <a:spLocks noChangeAspect="1" noChangeArrowheads="1"/>
            </p:cNvSpPr>
            <p:nvPr/>
          </p:nvSpPr>
          <p:spPr bwMode="auto">
            <a:xfrm>
              <a:off x="4073431" y="2788850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Oval 59"/>
            <p:cNvSpPr>
              <a:spLocks noChangeAspect="1" noChangeArrowheads="1"/>
            </p:cNvSpPr>
            <p:nvPr/>
          </p:nvSpPr>
          <p:spPr bwMode="auto">
            <a:xfrm>
              <a:off x="4073431" y="2788850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Oval 60"/>
            <p:cNvSpPr>
              <a:spLocks noChangeAspect="1" noChangeArrowheads="1"/>
            </p:cNvSpPr>
            <p:nvPr/>
          </p:nvSpPr>
          <p:spPr bwMode="auto">
            <a:xfrm>
              <a:off x="5380667" y="3129205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Oval 61"/>
            <p:cNvSpPr>
              <a:spLocks noChangeAspect="1" noChangeArrowheads="1"/>
            </p:cNvSpPr>
            <p:nvPr/>
          </p:nvSpPr>
          <p:spPr bwMode="auto">
            <a:xfrm>
              <a:off x="5380667" y="3129205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Oval 62"/>
            <p:cNvSpPr>
              <a:spLocks noChangeAspect="1" noChangeArrowheads="1"/>
            </p:cNvSpPr>
            <p:nvPr/>
          </p:nvSpPr>
          <p:spPr bwMode="auto">
            <a:xfrm>
              <a:off x="3510481" y="2242767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Oval 63"/>
            <p:cNvSpPr>
              <a:spLocks noChangeAspect="1" noChangeArrowheads="1"/>
            </p:cNvSpPr>
            <p:nvPr/>
          </p:nvSpPr>
          <p:spPr bwMode="auto">
            <a:xfrm>
              <a:off x="3510481" y="2242767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Oval 64"/>
            <p:cNvSpPr>
              <a:spLocks noChangeAspect="1" noChangeArrowheads="1"/>
            </p:cNvSpPr>
            <p:nvPr/>
          </p:nvSpPr>
          <p:spPr bwMode="auto">
            <a:xfrm>
              <a:off x="5483514" y="3229043"/>
              <a:ext cx="68204" cy="74424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Oval 65"/>
            <p:cNvSpPr>
              <a:spLocks noChangeAspect="1" noChangeArrowheads="1"/>
            </p:cNvSpPr>
            <p:nvPr/>
          </p:nvSpPr>
          <p:spPr bwMode="auto">
            <a:xfrm>
              <a:off x="5483514" y="3229043"/>
              <a:ext cx="68204" cy="74424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Oval 66"/>
            <p:cNvSpPr>
              <a:spLocks noChangeAspect="1" noChangeArrowheads="1"/>
            </p:cNvSpPr>
            <p:nvPr/>
          </p:nvSpPr>
          <p:spPr bwMode="auto">
            <a:xfrm>
              <a:off x="6614827" y="2834230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Oval 67"/>
            <p:cNvSpPr>
              <a:spLocks noChangeAspect="1" noChangeArrowheads="1"/>
            </p:cNvSpPr>
            <p:nvPr/>
          </p:nvSpPr>
          <p:spPr bwMode="auto">
            <a:xfrm>
              <a:off x="6614827" y="2834230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Oval 68"/>
            <p:cNvSpPr>
              <a:spLocks noChangeAspect="1" noChangeArrowheads="1"/>
            </p:cNvSpPr>
            <p:nvPr/>
          </p:nvSpPr>
          <p:spPr bwMode="auto">
            <a:xfrm>
              <a:off x="4555187" y="2322940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Oval 69"/>
            <p:cNvSpPr>
              <a:spLocks noChangeAspect="1" noChangeArrowheads="1"/>
            </p:cNvSpPr>
            <p:nvPr/>
          </p:nvSpPr>
          <p:spPr bwMode="auto">
            <a:xfrm>
              <a:off x="4555187" y="2322940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Oval 70"/>
            <p:cNvSpPr>
              <a:spLocks noChangeAspect="1" noChangeArrowheads="1"/>
            </p:cNvSpPr>
            <p:nvPr/>
          </p:nvSpPr>
          <p:spPr bwMode="auto">
            <a:xfrm>
              <a:off x="4492938" y="3425693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Oval 71"/>
            <p:cNvSpPr>
              <a:spLocks noChangeAspect="1" noChangeArrowheads="1"/>
            </p:cNvSpPr>
            <p:nvPr/>
          </p:nvSpPr>
          <p:spPr bwMode="auto">
            <a:xfrm>
              <a:off x="4492938" y="3425693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Oval 72"/>
            <p:cNvSpPr>
              <a:spLocks noChangeAspect="1" noChangeArrowheads="1"/>
            </p:cNvSpPr>
            <p:nvPr/>
          </p:nvSpPr>
          <p:spPr bwMode="auto">
            <a:xfrm>
              <a:off x="3514541" y="2729854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Oval 73"/>
            <p:cNvSpPr>
              <a:spLocks noChangeAspect="1" noChangeArrowheads="1"/>
            </p:cNvSpPr>
            <p:nvPr/>
          </p:nvSpPr>
          <p:spPr bwMode="auto">
            <a:xfrm>
              <a:off x="3513188" y="2729854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Oval 74"/>
            <p:cNvSpPr>
              <a:spLocks noChangeAspect="1" noChangeArrowheads="1"/>
            </p:cNvSpPr>
            <p:nvPr/>
          </p:nvSpPr>
          <p:spPr bwMode="auto">
            <a:xfrm>
              <a:off x="4069372" y="2908352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Oval 75"/>
            <p:cNvSpPr>
              <a:spLocks noChangeAspect="1" noChangeArrowheads="1"/>
            </p:cNvSpPr>
            <p:nvPr/>
          </p:nvSpPr>
          <p:spPr bwMode="auto">
            <a:xfrm>
              <a:off x="4069372" y="2908352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Oval 76"/>
            <p:cNvSpPr>
              <a:spLocks noChangeAspect="1" noChangeArrowheads="1"/>
            </p:cNvSpPr>
            <p:nvPr/>
          </p:nvSpPr>
          <p:spPr bwMode="auto">
            <a:xfrm>
              <a:off x="3686403" y="2459082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Oval 77"/>
            <p:cNvSpPr>
              <a:spLocks noChangeAspect="1" noChangeArrowheads="1"/>
            </p:cNvSpPr>
            <p:nvPr/>
          </p:nvSpPr>
          <p:spPr bwMode="auto">
            <a:xfrm>
              <a:off x="3686403" y="2459082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Oval 78"/>
            <p:cNvSpPr>
              <a:spLocks noChangeAspect="1" noChangeArrowheads="1"/>
            </p:cNvSpPr>
            <p:nvPr/>
          </p:nvSpPr>
          <p:spPr bwMode="auto">
            <a:xfrm>
              <a:off x="5173621" y="3285013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Oval 79"/>
            <p:cNvSpPr>
              <a:spLocks noChangeAspect="1" noChangeArrowheads="1"/>
            </p:cNvSpPr>
            <p:nvPr/>
          </p:nvSpPr>
          <p:spPr bwMode="auto">
            <a:xfrm>
              <a:off x="5173621" y="3285013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Oval 80"/>
            <p:cNvSpPr>
              <a:spLocks noChangeAspect="1" noChangeArrowheads="1"/>
            </p:cNvSpPr>
            <p:nvPr/>
          </p:nvSpPr>
          <p:spPr bwMode="auto">
            <a:xfrm>
              <a:off x="5593127" y="3233582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Oval 81"/>
            <p:cNvSpPr>
              <a:spLocks noChangeAspect="1" noChangeArrowheads="1"/>
            </p:cNvSpPr>
            <p:nvPr/>
          </p:nvSpPr>
          <p:spPr bwMode="auto">
            <a:xfrm>
              <a:off x="5593127" y="3233582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Oval 82"/>
            <p:cNvSpPr>
              <a:spLocks noChangeAspect="1" noChangeArrowheads="1"/>
            </p:cNvSpPr>
            <p:nvPr/>
          </p:nvSpPr>
          <p:spPr bwMode="auto">
            <a:xfrm>
              <a:off x="3672871" y="3162485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Oval 83"/>
            <p:cNvSpPr>
              <a:spLocks noChangeAspect="1" noChangeArrowheads="1"/>
            </p:cNvSpPr>
            <p:nvPr/>
          </p:nvSpPr>
          <p:spPr bwMode="auto">
            <a:xfrm>
              <a:off x="3672871" y="3162485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Oval 84"/>
            <p:cNvSpPr>
              <a:spLocks noChangeAspect="1" noChangeArrowheads="1"/>
            </p:cNvSpPr>
            <p:nvPr/>
          </p:nvSpPr>
          <p:spPr bwMode="auto">
            <a:xfrm>
              <a:off x="4602551" y="3071723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Oval 85"/>
            <p:cNvSpPr>
              <a:spLocks noChangeAspect="1" noChangeArrowheads="1"/>
            </p:cNvSpPr>
            <p:nvPr/>
          </p:nvSpPr>
          <p:spPr bwMode="auto">
            <a:xfrm>
              <a:off x="4602551" y="3071723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Oval 86"/>
            <p:cNvSpPr>
              <a:spLocks noChangeAspect="1" noChangeArrowheads="1"/>
            </p:cNvSpPr>
            <p:nvPr/>
          </p:nvSpPr>
          <p:spPr bwMode="auto">
            <a:xfrm>
              <a:off x="4942215" y="3552760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Oval 87"/>
            <p:cNvSpPr>
              <a:spLocks noChangeAspect="1" noChangeArrowheads="1"/>
            </p:cNvSpPr>
            <p:nvPr/>
          </p:nvSpPr>
          <p:spPr bwMode="auto">
            <a:xfrm>
              <a:off x="4942215" y="3552760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Oval 88"/>
            <p:cNvSpPr>
              <a:spLocks noChangeAspect="1" noChangeArrowheads="1"/>
            </p:cNvSpPr>
            <p:nvPr/>
          </p:nvSpPr>
          <p:spPr bwMode="auto">
            <a:xfrm>
              <a:off x="4068019" y="2763133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Oval 89"/>
            <p:cNvSpPr>
              <a:spLocks noChangeAspect="1" noChangeArrowheads="1"/>
            </p:cNvSpPr>
            <p:nvPr/>
          </p:nvSpPr>
          <p:spPr bwMode="auto">
            <a:xfrm>
              <a:off x="4068019" y="2763133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Oval 90"/>
            <p:cNvSpPr>
              <a:spLocks noChangeAspect="1" noChangeArrowheads="1"/>
            </p:cNvSpPr>
            <p:nvPr/>
          </p:nvSpPr>
          <p:spPr bwMode="auto">
            <a:xfrm>
              <a:off x="6187201" y="3826558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Oval 91"/>
            <p:cNvSpPr>
              <a:spLocks noChangeAspect="1" noChangeArrowheads="1"/>
            </p:cNvSpPr>
            <p:nvPr/>
          </p:nvSpPr>
          <p:spPr bwMode="auto">
            <a:xfrm>
              <a:off x="6187201" y="3826558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Oval 92"/>
            <p:cNvSpPr>
              <a:spLocks noChangeAspect="1" noChangeArrowheads="1"/>
            </p:cNvSpPr>
            <p:nvPr/>
          </p:nvSpPr>
          <p:spPr bwMode="auto">
            <a:xfrm>
              <a:off x="4797418" y="3477125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Oval 93"/>
            <p:cNvSpPr>
              <a:spLocks noChangeAspect="1" noChangeArrowheads="1"/>
            </p:cNvSpPr>
            <p:nvPr/>
          </p:nvSpPr>
          <p:spPr bwMode="auto">
            <a:xfrm>
              <a:off x="4797418" y="3477125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Oval 94"/>
            <p:cNvSpPr>
              <a:spLocks noChangeAspect="1" noChangeArrowheads="1"/>
            </p:cNvSpPr>
            <p:nvPr/>
          </p:nvSpPr>
          <p:spPr bwMode="auto">
            <a:xfrm>
              <a:off x="4911091" y="2430341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Oval 95"/>
            <p:cNvSpPr>
              <a:spLocks noChangeAspect="1" noChangeArrowheads="1"/>
            </p:cNvSpPr>
            <p:nvPr/>
          </p:nvSpPr>
          <p:spPr bwMode="auto">
            <a:xfrm>
              <a:off x="4911091" y="2430341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Oval 96"/>
            <p:cNvSpPr>
              <a:spLocks noChangeAspect="1" noChangeArrowheads="1"/>
            </p:cNvSpPr>
            <p:nvPr/>
          </p:nvSpPr>
          <p:spPr bwMode="auto">
            <a:xfrm>
              <a:off x="5122197" y="4555676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Oval 97"/>
            <p:cNvSpPr>
              <a:spLocks noChangeAspect="1" noChangeArrowheads="1"/>
            </p:cNvSpPr>
            <p:nvPr/>
          </p:nvSpPr>
          <p:spPr bwMode="auto">
            <a:xfrm>
              <a:off x="5122197" y="4555676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Oval 98"/>
            <p:cNvSpPr>
              <a:spLocks noChangeAspect="1" noChangeArrowheads="1"/>
            </p:cNvSpPr>
            <p:nvPr/>
          </p:nvSpPr>
          <p:spPr bwMode="auto">
            <a:xfrm>
              <a:off x="6475443" y="3517968"/>
              <a:ext cx="66579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Oval 99"/>
            <p:cNvSpPr>
              <a:spLocks noChangeAspect="1" noChangeArrowheads="1"/>
            </p:cNvSpPr>
            <p:nvPr/>
          </p:nvSpPr>
          <p:spPr bwMode="auto">
            <a:xfrm>
              <a:off x="6475443" y="3517968"/>
              <a:ext cx="66579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Oval 100"/>
            <p:cNvSpPr>
              <a:spLocks noChangeAspect="1" noChangeArrowheads="1"/>
            </p:cNvSpPr>
            <p:nvPr/>
          </p:nvSpPr>
          <p:spPr bwMode="auto">
            <a:xfrm>
              <a:off x="3505068" y="3366699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Oval 101"/>
            <p:cNvSpPr>
              <a:spLocks noChangeAspect="1" noChangeArrowheads="1"/>
            </p:cNvSpPr>
            <p:nvPr/>
          </p:nvSpPr>
          <p:spPr bwMode="auto">
            <a:xfrm>
              <a:off x="3505068" y="3366699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Oval 102"/>
            <p:cNvSpPr>
              <a:spLocks noChangeAspect="1" noChangeArrowheads="1"/>
            </p:cNvSpPr>
            <p:nvPr/>
          </p:nvSpPr>
          <p:spPr bwMode="auto">
            <a:xfrm>
              <a:off x="4639088" y="2965834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Oval 103"/>
            <p:cNvSpPr>
              <a:spLocks noChangeAspect="1" noChangeArrowheads="1"/>
            </p:cNvSpPr>
            <p:nvPr/>
          </p:nvSpPr>
          <p:spPr bwMode="auto">
            <a:xfrm>
              <a:off x="4639088" y="2965834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Oval 104"/>
            <p:cNvSpPr>
              <a:spLocks noChangeAspect="1" noChangeArrowheads="1"/>
            </p:cNvSpPr>
            <p:nvPr/>
          </p:nvSpPr>
          <p:spPr bwMode="auto">
            <a:xfrm>
              <a:off x="7158832" y="3732771"/>
              <a:ext cx="68204" cy="74424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Oval 105"/>
            <p:cNvSpPr>
              <a:spLocks noChangeAspect="1" noChangeArrowheads="1"/>
            </p:cNvSpPr>
            <p:nvPr/>
          </p:nvSpPr>
          <p:spPr bwMode="auto">
            <a:xfrm>
              <a:off x="7158832" y="3732771"/>
              <a:ext cx="68204" cy="74424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Oval 106"/>
            <p:cNvSpPr>
              <a:spLocks noChangeAspect="1" noChangeArrowheads="1"/>
            </p:cNvSpPr>
            <p:nvPr/>
          </p:nvSpPr>
          <p:spPr bwMode="auto">
            <a:xfrm>
              <a:off x="6345531" y="3280475"/>
              <a:ext cx="68204" cy="76240"/>
            </a:xfrm>
            <a:prstGeom prst="ellipse">
              <a:avLst/>
            </a:prstGeom>
            <a:solidFill>
              <a:schemeClr val="tx1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Oval 107"/>
            <p:cNvSpPr>
              <a:spLocks noChangeAspect="1" noChangeArrowheads="1"/>
            </p:cNvSpPr>
            <p:nvPr/>
          </p:nvSpPr>
          <p:spPr bwMode="auto">
            <a:xfrm>
              <a:off x="6345531" y="3280475"/>
              <a:ext cx="68204" cy="76240"/>
            </a:xfrm>
            <a:prstGeom prst="ellipse">
              <a:avLst/>
            </a:prstGeom>
            <a:solidFill>
              <a:schemeClr val="tx1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F3195599-582E-BA88-2157-0BC8F3AA12C6}"/>
                </a:ext>
              </a:extLst>
            </p:cNvPr>
            <p:cNvSpPr txBox="1"/>
            <p:nvPr/>
          </p:nvSpPr>
          <p:spPr>
            <a:xfrm rot="16200000">
              <a:off x="1148411" y="3141480"/>
              <a:ext cx="1544575" cy="2623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Δlymphocyte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/µL)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63F5FBA3-7145-D774-150B-7F1BF1EDAA35}"/>
                </a:ext>
              </a:extLst>
            </p:cNvPr>
            <p:cNvSpPr txBox="1"/>
            <p:nvPr/>
          </p:nvSpPr>
          <p:spPr>
            <a:xfrm>
              <a:off x="5112082" y="5505448"/>
              <a:ext cx="650710" cy="2932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R2w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Freeform 108"/>
            <p:cNvSpPr>
              <a:spLocks noChangeAspect="1"/>
            </p:cNvSpPr>
            <p:nvPr/>
          </p:nvSpPr>
          <p:spPr bwMode="auto">
            <a:xfrm>
              <a:off x="2850104" y="2594587"/>
              <a:ext cx="5005551" cy="1282023"/>
            </a:xfrm>
            <a:custGeom>
              <a:avLst/>
              <a:gdLst>
                <a:gd name="T0" fmla="*/ 57 w 4251"/>
                <a:gd name="T1" fmla="*/ 13 h 974"/>
                <a:gd name="T2" fmla="*/ 132 w 4251"/>
                <a:gd name="T3" fmla="*/ 31 h 974"/>
                <a:gd name="T4" fmla="*/ 208 w 4251"/>
                <a:gd name="T5" fmla="*/ 48 h 974"/>
                <a:gd name="T6" fmla="*/ 283 w 4251"/>
                <a:gd name="T7" fmla="*/ 65 h 974"/>
                <a:gd name="T8" fmla="*/ 359 w 4251"/>
                <a:gd name="T9" fmla="*/ 82 h 974"/>
                <a:gd name="T10" fmla="*/ 434 w 4251"/>
                <a:gd name="T11" fmla="*/ 100 h 974"/>
                <a:gd name="T12" fmla="*/ 510 w 4251"/>
                <a:gd name="T13" fmla="*/ 117 h 974"/>
                <a:gd name="T14" fmla="*/ 586 w 4251"/>
                <a:gd name="T15" fmla="*/ 134 h 974"/>
                <a:gd name="T16" fmla="*/ 661 w 4251"/>
                <a:gd name="T17" fmla="*/ 152 h 974"/>
                <a:gd name="T18" fmla="*/ 737 w 4251"/>
                <a:gd name="T19" fmla="*/ 169 h 974"/>
                <a:gd name="T20" fmla="*/ 812 w 4251"/>
                <a:gd name="T21" fmla="*/ 187 h 974"/>
                <a:gd name="T22" fmla="*/ 888 w 4251"/>
                <a:gd name="T23" fmla="*/ 204 h 974"/>
                <a:gd name="T24" fmla="*/ 963 w 4251"/>
                <a:gd name="T25" fmla="*/ 221 h 974"/>
                <a:gd name="T26" fmla="*/ 1039 w 4251"/>
                <a:gd name="T27" fmla="*/ 239 h 974"/>
                <a:gd name="T28" fmla="*/ 1114 w 4251"/>
                <a:gd name="T29" fmla="*/ 256 h 974"/>
                <a:gd name="T30" fmla="*/ 1190 w 4251"/>
                <a:gd name="T31" fmla="*/ 273 h 974"/>
                <a:gd name="T32" fmla="*/ 1266 w 4251"/>
                <a:gd name="T33" fmla="*/ 291 h 974"/>
                <a:gd name="T34" fmla="*/ 1341 w 4251"/>
                <a:gd name="T35" fmla="*/ 308 h 974"/>
                <a:gd name="T36" fmla="*/ 1417 w 4251"/>
                <a:gd name="T37" fmla="*/ 325 h 974"/>
                <a:gd name="T38" fmla="*/ 1492 w 4251"/>
                <a:gd name="T39" fmla="*/ 342 h 974"/>
                <a:gd name="T40" fmla="*/ 1568 w 4251"/>
                <a:gd name="T41" fmla="*/ 360 h 974"/>
                <a:gd name="T42" fmla="*/ 1644 w 4251"/>
                <a:gd name="T43" fmla="*/ 377 h 974"/>
                <a:gd name="T44" fmla="*/ 1719 w 4251"/>
                <a:gd name="T45" fmla="*/ 394 h 974"/>
                <a:gd name="T46" fmla="*/ 1795 w 4251"/>
                <a:gd name="T47" fmla="*/ 412 h 974"/>
                <a:gd name="T48" fmla="*/ 1870 w 4251"/>
                <a:gd name="T49" fmla="*/ 429 h 974"/>
                <a:gd name="T50" fmla="*/ 1946 w 4251"/>
                <a:gd name="T51" fmla="*/ 446 h 974"/>
                <a:gd name="T52" fmla="*/ 2022 w 4251"/>
                <a:gd name="T53" fmla="*/ 464 h 974"/>
                <a:gd name="T54" fmla="*/ 2097 w 4251"/>
                <a:gd name="T55" fmla="*/ 481 h 974"/>
                <a:gd name="T56" fmla="*/ 2173 w 4251"/>
                <a:gd name="T57" fmla="*/ 498 h 974"/>
                <a:gd name="T58" fmla="*/ 2248 w 4251"/>
                <a:gd name="T59" fmla="*/ 515 h 974"/>
                <a:gd name="T60" fmla="*/ 2324 w 4251"/>
                <a:gd name="T61" fmla="*/ 533 h 974"/>
                <a:gd name="T62" fmla="*/ 2400 w 4251"/>
                <a:gd name="T63" fmla="*/ 550 h 974"/>
                <a:gd name="T64" fmla="*/ 2475 w 4251"/>
                <a:gd name="T65" fmla="*/ 567 h 974"/>
                <a:gd name="T66" fmla="*/ 2551 w 4251"/>
                <a:gd name="T67" fmla="*/ 585 h 974"/>
                <a:gd name="T68" fmla="*/ 2626 w 4251"/>
                <a:gd name="T69" fmla="*/ 602 h 974"/>
                <a:gd name="T70" fmla="*/ 2702 w 4251"/>
                <a:gd name="T71" fmla="*/ 619 h 974"/>
                <a:gd name="T72" fmla="*/ 2777 w 4251"/>
                <a:gd name="T73" fmla="*/ 637 h 974"/>
                <a:gd name="T74" fmla="*/ 2853 w 4251"/>
                <a:gd name="T75" fmla="*/ 654 h 974"/>
                <a:gd name="T76" fmla="*/ 2928 w 4251"/>
                <a:gd name="T77" fmla="*/ 671 h 974"/>
                <a:gd name="T78" fmla="*/ 3004 w 4251"/>
                <a:gd name="T79" fmla="*/ 689 h 974"/>
                <a:gd name="T80" fmla="*/ 3079 w 4251"/>
                <a:gd name="T81" fmla="*/ 706 h 974"/>
                <a:gd name="T82" fmla="*/ 3155 w 4251"/>
                <a:gd name="T83" fmla="*/ 723 h 974"/>
                <a:gd name="T84" fmla="*/ 3231 w 4251"/>
                <a:gd name="T85" fmla="*/ 740 h 974"/>
                <a:gd name="T86" fmla="*/ 3306 w 4251"/>
                <a:gd name="T87" fmla="*/ 758 h 974"/>
                <a:gd name="T88" fmla="*/ 3382 w 4251"/>
                <a:gd name="T89" fmla="*/ 775 h 974"/>
                <a:gd name="T90" fmla="*/ 3457 w 4251"/>
                <a:gd name="T91" fmla="*/ 792 h 974"/>
                <a:gd name="T92" fmla="*/ 3533 w 4251"/>
                <a:gd name="T93" fmla="*/ 810 h 974"/>
                <a:gd name="T94" fmla="*/ 3608 w 4251"/>
                <a:gd name="T95" fmla="*/ 827 h 974"/>
                <a:gd name="T96" fmla="*/ 3684 w 4251"/>
                <a:gd name="T97" fmla="*/ 844 h 974"/>
                <a:gd name="T98" fmla="*/ 3760 w 4251"/>
                <a:gd name="T99" fmla="*/ 862 h 974"/>
                <a:gd name="T100" fmla="*/ 3835 w 4251"/>
                <a:gd name="T101" fmla="*/ 879 h 974"/>
                <a:gd name="T102" fmla="*/ 3911 w 4251"/>
                <a:gd name="T103" fmla="*/ 897 h 974"/>
                <a:gd name="T104" fmla="*/ 3986 w 4251"/>
                <a:gd name="T105" fmla="*/ 914 h 974"/>
                <a:gd name="T106" fmla="*/ 4062 w 4251"/>
                <a:gd name="T107" fmla="*/ 931 h 974"/>
                <a:gd name="T108" fmla="*/ 4138 w 4251"/>
                <a:gd name="T109" fmla="*/ 949 h 974"/>
                <a:gd name="T110" fmla="*/ 4213 w 4251"/>
                <a:gd name="T111" fmla="*/ 966 h 9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251" h="974">
                  <a:moveTo>
                    <a:pt x="0" y="0"/>
                  </a:moveTo>
                  <a:lnTo>
                    <a:pt x="19" y="5"/>
                  </a:lnTo>
                  <a:lnTo>
                    <a:pt x="38" y="9"/>
                  </a:lnTo>
                  <a:lnTo>
                    <a:pt x="57" y="13"/>
                  </a:lnTo>
                  <a:lnTo>
                    <a:pt x="75" y="18"/>
                  </a:lnTo>
                  <a:lnTo>
                    <a:pt x="94" y="22"/>
                  </a:lnTo>
                  <a:lnTo>
                    <a:pt x="113" y="26"/>
                  </a:lnTo>
                  <a:lnTo>
                    <a:pt x="132" y="31"/>
                  </a:lnTo>
                  <a:lnTo>
                    <a:pt x="151" y="35"/>
                  </a:lnTo>
                  <a:lnTo>
                    <a:pt x="170" y="39"/>
                  </a:lnTo>
                  <a:lnTo>
                    <a:pt x="189" y="44"/>
                  </a:lnTo>
                  <a:lnTo>
                    <a:pt x="208" y="48"/>
                  </a:lnTo>
                  <a:lnTo>
                    <a:pt x="227" y="52"/>
                  </a:lnTo>
                  <a:lnTo>
                    <a:pt x="245" y="57"/>
                  </a:lnTo>
                  <a:lnTo>
                    <a:pt x="265" y="61"/>
                  </a:lnTo>
                  <a:lnTo>
                    <a:pt x="283" y="65"/>
                  </a:lnTo>
                  <a:lnTo>
                    <a:pt x="302" y="70"/>
                  </a:lnTo>
                  <a:lnTo>
                    <a:pt x="321" y="74"/>
                  </a:lnTo>
                  <a:lnTo>
                    <a:pt x="340" y="78"/>
                  </a:lnTo>
                  <a:lnTo>
                    <a:pt x="359" y="82"/>
                  </a:lnTo>
                  <a:lnTo>
                    <a:pt x="378" y="87"/>
                  </a:lnTo>
                  <a:lnTo>
                    <a:pt x="397" y="91"/>
                  </a:lnTo>
                  <a:lnTo>
                    <a:pt x="416" y="95"/>
                  </a:lnTo>
                  <a:lnTo>
                    <a:pt x="434" y="100"/>
                  </a:lnTo>
                  <a:lnTo>
                    <a:pt x="453" y="104"/>
                  </a:lnTo>
                  <a:lnTo>
                    <a:pt x="472" y="108"/>
                  </a:lnTo>
                  <a:lnTo>
                    <a:pt x="491" y="113"/>
                  </a:lnTo>
                  <a:lnTo>
                    <a:pt x="510" y="117"/>
                  </a:lnTo>
                  <a:lnTo>
                    <a:pt x="529" y="121"/>
                  </a:lnTo>
                  <a:lnTo>
                    <a:pt x="548" y="126"/>
                  </a:lnTo>
                  <a:lnTo>
                    <a:pt x="567" y="130"/>
                  </a:lnTo>
                  <a:lnTo>
                    <a:pt x="586" y="134"/>
                  </a:lnTo>
                  <a:lnTo>
                    <a:pt x="604" y="139"/>
                  </a:lnTo>
                  <a:lnTo>
                    <a:pt x="623" y="143"/>
                  </a:lnTo>
                  <a:lnTo>
                    <a:pt x="642" y="147"/>
                  </a:lnTo>
                  <a:lnTo>
                    <a:pt x="661" y="152"/>
                  </a:lnTo>
                  <a:lnTo>
                    <a:pt x="680" y="156"/>
                  </a:lnTo>
                  <a:lnTo>
                    <a:pt x="699" y="160"/>
                  </a:lnTo>
                  <a:lnTo>
                    <a:pt x="718" y="165"/>
                  </a:lnTo>
                  <a:lnTo>
                    <a:pt x="737" y="169"/>
                  </a:lnTo>
                  <a:lnTo>
                    <a:pt x="756" y="173"/>
                  </a:lnTo>
                  <a:lnTo>
                    <a:pt x="775" y="178"/>
                  </a:lnTo>
                  <a:lnTo>
                    <a:pt x="794" y="182"/>
                  </a:lnTo>
                  <a:lnTo>
                    <a:pt x="812" y="187"/>
                  </a:lnTo>
                  <a:lnTo>
                    <a:pt x="831" y="191"/>
                  </a:lnTo>
                  <a:lnTo>
                    <a:pt x="850" y="195"/>
                  </a:lnTo>
                  <a:lnTo>
                    <a:pt x="869" y="200"/>
                  </a:lnTo>
                  <a:lnTo>
                    <a:pt x="888" y="204"/>
                  </a:lnTo>
                  <a:lnTo>
                    <a:pt x="907" y="208"/>
                  </a:lnTo>
                  <a:lnTo>
                    <a:pt x="926" y="213"/>
                  </a:lnTo>
                  <a:lnTo>
                    <a:pt x="945" y="217"/>
                  </a:lnTo>
                  <a:lnTo>
                    <a:pt x="963" y="221"/>
                  </a:lnTo>
                  <a:lnTo>
                    <a:pt x="982" y="226"/>
                  </a:lnTo>
                  <a:lnTo>
                    <a:pt x="1001" y="230"/>
                  </a:lnTo>
                  <a:lnTo>
                    <a:pt x="1020" y="234"/>
                  </a:lnTo>
                  <a:lnTo>
                    <a:pt x="1039" y="239"/>
                  </a:lnTo>
                  <a:lnTo>
                    <a:pt x="1058" y="243"/>
                  </a:lnTo>
                  <a:lnTo>
                    <a:pt x="1077" y="247"/>
                  </a:lnTo>
                  <a:lnTo>
                    <a:pt x="1096" y="252"/>
                  </a:lnTo>
                  <a:lnTo>
                    <a:pt x="1114" y="256"/>
                  </a:lnTo>
                  <a:lnTo>
                    <a:pt x="1134" y="260"/>
                  </a:lnTo>
                  <a:lnTo>
                    <a:pt x="1153" y="265"/>
                  </a:lnTo>
                  <a:lnTo>
                    <a:pt x="1171" y="269"/>
                  </a:lnTo>
                  <a:lnTo>
                    <a:pt x="1190" y="273"/>
                  </a:lnTo>
                  <a:lnTo>
                    <a:pt x="1209" y="278"/>
                  </a:lnTo>
                  <a:lnTo>
                    <a:pt x="1228" y="282"/>
                  </a:lnTo>
                  <a:lnTo>
                    <a:pt x="1247" y="286"/>
                  </a:lnTo>
                  <a:lnTo>
                    <a:pt x="1266" y="291"/>
                  </a:lnTo>
                  <a:lnTo>
                    <a:pt x="1285" y="295"/>
                  </a:lnTo>
                  <a:lnTo>
                    <a:pt x="1304" y="299"/>
                  </a:lnTo>
                  <a:lnTo>
                    <a:pt x="1322" y="304"/>
                  </a:lnTo>
                  <a:lnTo>
                    <a:pt x="1341" y="308"/>
                  </a:lnTo>
                  <a:lnTo>
                    <a:pt x="1360" y="312"/>
                  </a:lnTo>
                  <a:lnTo>
                    <a:pt x="1379" y="316"/>
                  </a:lnTo>
                  <a:lnTo>
                    <a:pt x="1398" y="321"/>
                  </a:lnTo>
                  <a:lnTo>
                    <a:pt x="1417" y="325"/>
                  </a:lnTo>
                  <a:lnTo>
                    <a:pt x="1436" y="329"/>
                  </a:lnTo>
                  <a:lnTo>
                    <a:pt x="1455" y="334"/>
                  </a:lnTo>
                  <a:lnTo>
                    <a:pt x="1473" y="338"/>
                  </a:lnTo>
                  <a:lnTo>
                    <a:pt x="1492" y="342"/>
                  </a:lnTo>
                  <a:lnTo>
                    <a:pt x="1512" y="347"/>
                  </a:lnTo>
                  <a:lnTo>
                    <a:pt x="1530" y="351"/>
                  </a:lnTo>
                  <a:lnTo>
                    <a:pt x="1549" y="355"/>
                  </a:lnTo>
                  <a:lnTo>
                    <a:pt x="1568" y="360"/>
                  </a:lnTo>
                  <a:lnTo>
                    <a:pt x="1587" y="364"/>
                  </a:lnTo>
                  <a:lnTo>
                    <a:pt x="1606" y="368"/>
                  </a:lnTo>
                  <a:lnTo>
                    <a:pt x="1625" y="373"/>
                  </a:lnTo>
                  <a:lnTo>
                    <a:pt x="1644" y="377"/>
                  </a:lnTo>
                  <a:lnTo>
                    <a:pt x="1663" y="381"/>
                  </a:lnTo>
                  <a:lnTo>
                    <a:pt x="1681" y="386"/>
                  </a:lnTo>
                  <a:lnTo>
                    <a:pt x="1700" y="390"/>
                  </a:lnTo>
                  <a:lnTo>
                    <a:pt x="1719" y="394"/>
                  </a:lnTo>
                  <a:lnTo>
                    <a:pt x="1738" y="399"/>
                  </a:lnTo>
                  <a:lnTo>
                    <a:pt x="1757" y="403"/>
                  </a:lnTo>
                  <a:lnTo>
                    <a:pt x="1776" y="407"/>
                  </a:lnTo>
                  <a:lnTo>
                    <a:pt x="1795" y="412"/>
                  </a:lnTo>
                  <a:lnTo>
                    <a:pt x="1814" y="416"/>
                  </a:lnTo>
                  <a:lnTo>
                    <a:pt x="1833" y="420"/>
                  </a:lnTo>
                  <a:lnTo>
                    <a:pt x="1851" y="425"/>
                  </a:lnTo>
                  <a:lnTo>
                    <a:pt x="1870" y="429"/>
                  </a:lnTo>
                  <a:lnTo>
                    <a:pt x="1889" y="433"/>
                  </a:lnTo>
                  <a:lnTo>
                    <a:pt x="1908" y="438"/>
                  </a:lnTo>
                  <a:lnTo>
                    <a:pt x="1927" y="442"/>
                  </a:lnTo>
                  <a:lnTo>
                    <a:pt x="1946" y="446"/>
                  </a:lnTo>
                  <a:lnTo>
                    <a:pt x="1965" y="451"/>
                  </a:lnTo>
                  <a:lnTo>
                    <a:pt x="1984" y="455"/>
                  </a:lnTo>
                  <a:lnTo>
                    <a:pt x="2002" y="459"/>
                  </a:lnTo>
                  <a:lnTo>
                    <a:pt x="2022" y="464"/>
                  </a:lnTo>
                  <a:lnTo>
                    <a:pt x="2040" y="468"/>
                  </a:lnTo>
                  <a:lnTo>
                    <a:pt x="2059" y="472"/>
                  </a:lnTo>
                  <a:lnTo>
                    <a:pt x="2078" y="477"/>
                  </a:lnTo>
                  <a:lnTo>
                    <a:pt x="2097" y="481"/>
                  </a:lnTo>
                  <a:lnTo>
                    <a:pt x="2116" y="485"/>
                  </a:lnTo>
                  <a:lnTo>
                    <a:pt x="2135" y="490"/>
                  </a:lnTo>
                  <a:lnTo>
                    <a:pt x="2154" y="494"/>
                  </a:lnTo>
                  <a:lnTo>
                    <a:pt x="2173" y="498"/>
                  </a:lnTo>
                  <a:lnTo>
                    <a:pt x="2192" y="503"/>
                  </a:lnTo>
                  <a:lnTo>
                    <a:pt x="2210" y="507"/>
                  </a:lnTo>
                  <a:lnTo>
                    <a:pt x="2229" y="511"/>
                  </a:lnTo>
                  <a:lnTo>
                    <a:pt x="2248" y="515"/>
                  </a:lnTo>
                  <a:lnTo>
                    <a:pt x="2267" y="520"/>
                  </a:lnTo>
                  <a:lnTo>
                    <a:pt x="2286" y="524"/>
                  </a:lnTo>
                  <a:lnTo>
                    <a:pt x="2305" y="528"/>
                  </a:lnTo>
                  <a:lnTo>
                    <a:pt x="2324" y="533"/>
                  </a:lnTo>
                  <a:lnTo>
                    <a:pt x="2343" y="537"/>
                  </a:lnTo>
                  <a:lnTo>
                    <a:pt x="2361" y="541"/>
                  </a:lnTo>
                  <a:lnTo>
                    <a:pt x="2381" y="546"/>
                  </a:lnTo>
                  <a:lnTo>
                    <a:pt x="2400" y="550"/>
                  </a:lnTo>
                  <a:lnTo>
                    <a:pt x="2418" y="554"/>
                  </a:lnTo>
                  <a:lnTo>
                    <a:pt x="2437" y="559"/>
                  </a:lnTo>
                  <a:lnTo>
                    <a:pt x="2456" y="563"/>
                  </a:lnTo>
                  <a:lnTo>
                    <a:pt x="2475" y="567"/>
                  </a:lnTo>
                  <a:lnTo>
                    <a:pt x="2494" y="572"/>
                  </a:lnTo>
                  <a:lnTo>
                    <a:pt x="2513" y="576"/>
                  </a:lnTo>
                  <a:lnTo>
                    <a:pt x="2532" y="580"/>
                  </a:lnTo>
                  <a:lnTo>
                    <a:pt x="2551" y="585"/>
                  </a:lnTo>
                  <a:lnTo>
                    <a:pt x="2569" y="589"/>
                  </a:lnTo>
                  <a:lnTo>
                    <a:pt x="2588" y="593"/>
                  </a:lnTo>
                  <a:lnTo>
                    <a:pt x="2607" y="598"/>
                  </a:lnTo>
                  <a:lnTo>
                    <a:pt x="2626" y="602"/>
                  </a:lnTo>
                  <a:lnTo>
                    <a:pt x="2645" y="606"/>
                  </a:lnTo>
                  <a:lnTo>
                    <a:pt x="2664" y="611"/>
                  </a:lnTo>
                  <a:lnTo>
                    <a:pt x="2683" y="615"/>
                  </a:lnTo>
                  <a:lnTo>
                    <a:pt x="2702" y="619"/>
                  </a:lnTo>
                  <a:lnTo>
                    <a:pt x="2720" y="624"/>
                  </a:lnTo>
                  <a:lnTo>
                    <a:pt x="2739" y="628"/>
                  </a:lnTo>
                  <a:lnTo>
                    <a:pt x="2759" y="632"/>
                  </a:lnTo>
                  <a:lnTo>
                    <a:pt x="2777" y="637"/>
                  </a:lnTo>
                  <a:lnTo>
                    <a:pt x="2796" y="641"/>
                  </a:lnTo>
                  <a:lnTo>
                    <a:pt x="2815" y="645"/>
                  </a:lnTo>
                  <a:lnTo>
                    <a:pt x="2834" y="650"/>
                  </a:lnTo>
                  <a:lnTo>
                    <a:pt x="2853" y="654"/>
                  </a:lnTo>
                  <a:lnTo>
                    <a:pt x="2872" y="658"/>
                  </a:lnTo>
                  <a:lnTo>
                    <a:pt x="2891" y="663"/>
                  </a:lnTo>
                  <a:lnTo>
                    <a:pt x="2910" y="667"/>
                  </a:lnTo>
                  <a:lnTo>
                    <a:pt x="2928" y="671"/>
                  </a:lnTo>
                  <a:lnTo>
                    <a:pt x="2947" y="676"/>
                  </a:lnTo>
                  <a:lnTo>
                    <a:pt x="2966" y="680"/>
                  </a:lnTo>
                  <a:lnTo>
                    <a:pt x="2985" y="684"/>
                  </a:lnTo>
                  <a:lnTo>
                    <a:pt x="3004" y="689"/>
                  </a:lnTo>
                  <a:lnTo>
                    <a:pt x="3023" y="693"/>
                  </a:lnTo>
                  <a:lnTo>
                    <a:pt x="3042" y="697"/>
                  </a:lnTo>
                  <a:lnTo>
                    <a:pt x="3061" y="702"/>
                  </a:lnTo>
                  <a:lnTo>
                    <a:pt x="3079" y="706"/>
                  </a:lnTo>
                  <a:lnTo>
                    <a:pt x="3098" y="710"/>
                  </a:lnTo>
                  <a:lnTo>
                    <a:pt x="3117" y="714"/>
                  </a:lnTo>
                  <a:lnTo>
                    <a:pt x="3136" y="719"/>
                  </a:lnTo>
                  <a:lnTo>
                    <a:pt x="3155" y="723"/>
                  </a:lnTo>
                  <a:lnTo>
                    <a:pt x="3174" y="727"/>
                  </a:lnTo>
                  <a:lnTo>
                    <a:pt x="3193" y="732"/>
                  </a:lnTo>
                  <a:lnTo>
                    <a:pt x="3212" y="736"/>
                  </a:lnTo>
                  <a:lnTo>
                    <a:pt x="3231" y="740"/>
                  </a:lnTo>
                  <a:lnTo>
                    <a:pt x="3249" y="745"/>
                  </a:lnTo>
                  <a:lnTo>
                    <a:pt x="3269" y="749"/>
                  </a:lnTo>
                  <a:lnTo>
                    <a:pt x="3287" y="753"/>
                  </a:lnTo>
                  <a:lnTo>
                    <a:pt x="3306" y="758"/>
                  </a:lnTo>
                  <a:lnTo>
                    <a:pt x="3325" y="762"/>
                  </a:lnTo>
                  <a:lnTo>
                    <a:pt x="3344" y="766"/>
                  </a:lnTo>
                  <a:lnTo>
                    <a:pt x="3363" y="771"/>
                  </a:lnTo>
                  <a:lnTo>
                    <a:pt x="3382" y="775"/>
                  </a:lnTo>
                  <a:lnTo>
                    <a:pt x="3401" y="779"/>
                  </a:lnTo>
                  <a:lnTo>
                    <a:pt x="3420" y="784"/>
                  </a:lnTo>
                  <a:lnTo>
                    <a:pt x="3439" y="788"/>
                  </a:lnTo>
                  <a:lnTo>
                    <a:pt x="3457" y="792"/>
                  </a:lnTo>
                  <a:lnTo>
                    <a:pt x="3476" y="797"/>
                  </a:lnTo>
                  <a:lnTo>
                    <a:pt x="3495" y="801"/>
                  </a:lnTo>
                  <a:lnTo>
                    <a:pt x="3514" y="805"/>
                  </a:lnTo>
                  <a:lnTo>
                    <a:pt x="3533" y="810"/>
                  </a:lnTo>
                  <a:lnTo>
                    <a:pt x="3552" y="814"/>
                  </a:lnTo>
                  <a:lnTo>
                    <a:pt x="3571" y="818"/>
                  </a:lnTo>
                  <a:lnTo>
                    <a:pt x="3590" y="823"/>
                  </a:lnTo>
                  <a:lnTo>
                    <a:pt x="3608" y="827"/>
                  </a:lnTo>
                  <a:lnTo>
                    <a:pt x="3627" y="831"/>
                  </a:lnTo>
                  <a:lnTo>
                    <a:pt x="3646" y="836"/>
                  </a:lnTo>
                  <a:lnTo>
                    <a:pt x="3665" y="840"/>
                  </a:lnTo>
                  <a:lnTo>
                    <a:pt x="3684" y="844"/>
                  </a:lnTo>
                  <a:lnTo>
                    <a:pt x="3703" y="849"/>
                  </a:lnTo>
                  <a:lnTo>
                    <a:pt x="3722" y="853"/>
                  </a:lnTo>
                  <a:lnTo>
                    <a:pt x="3741" y="858"/>
                  </a:lnTo>
                  <a:lnTo>
                    <a:pt x="3760" y="862"/>
                  </a:lnTo>
                  <a:lnTo>
                    <a:pt x="3779" y="866"/>
                  </a:lnTo>
                  <a:lnTo>
                    <a:pt x="3798" y="871"/>
                  </a:lnTo>
                  <a:lnTo>
                    <a:pt x="3816" y="875"/>
                  </a:lnTo>
                  <a:lnTo>
                    <a:pt x="3835" y="879"/>
                  </a:lnTo>
                  <a:lnTo>
                    <a:pt x="3854" y="884"/>
                  </a:lnTo>
                  <a:lnTo>
                    <a:pt x="3873" y="888"/>
                  </a:lnTo>
                  <a:lnTo>
                    <a:pt x="3892" y="892"/>
                  </a:lnTo>
                  <a:lnTo>
                    <a:pt x="3911" y="897"/>
                  </a:lnTo>
                  <a:lnTo>
                    <a:pt x="3930" y="901"/>
                  </a:lnTo>
                  <a:lnTo>
                    <a:pt x="3949" y="905"/>
                  </a:lnTo>
                  <a:lnTo>
                    <a:pt x="3967" y="910"/>
                  </a:lnTo>
                  <a:lnTo>
                    <a:pt x="3986" y="914"/>
                  </a:lnTo>
                  <a:lnTo>
                    <a:pt x="4006" y="918"/>
                  </a:lnTo>
                  <a:lnTo>
                    <a:pt x="4024" y="923"/>
                  </a:lnTo>
                  <a:lnTo>
                    <a:pt x="4043" y="927"/>
                  </a:lnTo>
                  <a:lnTo>
                    <a:pt x="4062" y="931"/>
                  </a:lnTo>
                  <a:lnTo>
                    <a:pt x="4081" y="936"/>
                  </a:lnTo>
                  <a:lnTo>
                    <a:pt x="4100" y="940"/>
                  </a:lnTo>
                  <a:lnTo>
                    <a:pt x="4119" y="944"/>
                  </a:lnTo>
                  <a:lnTo>
                    <a:pt x="4138" y="949"/>
                  </a:lnTo>
                  <a:lnTo>
                    <a:pt x="4157" y="953"/>
                  </a:lnTo>
                  <a:lnTo>
                    <a:pt x="4175" y="957"/>
                  </a:lnTo>
                  <a:lnTo>
                    <a:pt x="4194" y="961"/>
                  </a:lnTo>
                  <a:lnTo>
                    <a:pt x="4213" y="966"/>
                  </a:lnTo>
                  <a:lnTo>
                    <a:pt x="4232" y="970"/>
                  </a:lnTo>
                  <a:lnTo>
                    <a:pt x="4251" y="974"/>
                  </a:lnTo>
                </a:path>
              </a:pathLst>
            </a:custGeom>
            <a:noFill/>
            <a:ln w="9525" cap="flat">
              <a:solidFill>
                <a:schemeClr val="tx1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テキスト ボックス 127"/>
            <p:cNvSpPr txBox="1"/>
            <p:nvPr/>
          </p:nvSpPr>
          <p:spPr>
            <a:xfrm>
              <a:off x="4728149" y="1421516"/>
              <a:ext cx="17363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 = −0.538, </a:t>
              </a:r>
              <a:r>
                <a:rPr lang="en-US" altLang="ja-JP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002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34323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5</TotalTime>
  <Words>107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一 本間</dc:creator>
  <cp:lastModifiedBy>雄一 本間</cp:lastModifiedBy>
  <cp:revision>41</cp:revision>
  <dcterms:created xsi:type="dcterms:W3CDTF">2024-11-23T09:58:41Z</dcterms:created>
  <dcterms:modified xsi:type="dcterms:W3CDTF">2025-03-03T13:36:36Z</dcterms:modified>
</cp:coreProperties>
</file>